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934200" cy="92344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933600" cy="923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3005280" cy="46188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27240" y="-360"/>
            <a:ext cx="3004920" cy="46188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58840" y="691920"/>
            <a:ext cx="4616640" cy="3462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2520" rIns="92520" tIns="46080" bIns="460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93720" y="4386240"/>
            <a:ext cx="5546880" cy="415440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769240"/>
            <a:ext cx="3005280" cy="46224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27240" y="8769240"/>
            <a:ext cx="3004920" cy="462240"/>
          </a:xfrm>
          <a:prstGeom prst="rect">
            <a:avLst/>
          </a:prstGeom>
          <a:noFill/>
          <a:ln w="0">
            <a:noFill/>
          </a:ln>
        </p:spPr>
        <p:txBody>
          <a:bodyPr lIns="92520" rIns="92520" tIns="46080" bIns="4608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1CF551A-DA82-44CF-99A9-5E50CCB9406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sldImg"/>
          </p:nvPr>
        </p:nvSpPr>
        <p:spPr>
          <a:xfrm>
            <a:off x="1158840" y="692280"/>
            <a:ext cx="4616640" cy="3462120"/>
          </a:xfrm>
          <a:prstGeom prst="rect">
            <a:avLst/>
          </a:prstGeom>
          <a:ln w="0">
            <a:noFill/>
          </a:ln>
        </p:spPr>
      </p:sp>
      <p:sp>
        <p:nvSpPr>
          <p:cNvPr id="56" name="PlaceHolder 2"/>
          <p:cNvSpPr>
            <a:spLocks noGrp="1"/>
          </p:cNvSpPr>
          <p:nvPr>
            <p:ph type="body"/>
          </p:nvPr>
        </p:nvSpPr>
        <p:spPr>
          <a:xfrm>
            <a:off x="693720" y="4386240"/>
            <a:ext cx="5546880" cy="4154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lide Number Placeholder 3"/>
          <p:cNvSpPr/>
          <p:nvPr/>
        </p:nvSpPr>
        <p:spPr>
          <a:xfrm>
            <a:off x="3927600" y="8769240"/>
            <a:ext cx="3004920" cy="462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2520" rIns="92520" tIns="46080" bIns="4608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F50AFD-85B7-4F3D-B27F-B2863EAC450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96966-9599-4E96-8FF2-3690D52883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95F76-FD33-4B6C-81C1-5CD6D094FD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196CF-0EA6-4311-B9A1-73C13D63080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92574-4F95-413B-9F98-3DDC4C670D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B85C9-F80B-4172-B7D7-4FDAF29A95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C4D136-8045-48C7-B003-BE0403DAF7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BDC06-7B1F-4277-88B5-A075AA91C7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28756-3E27-4A64-93FC-12D72AC9BB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CDEC5F-6C5E-4BCC-AFE9-100BE70447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F4DE1-ECDE-409A-8A2D-B934255FF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2717C-2FC3-4D9A-B4D9-FBEB841430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CA99B-2E3E-4D3F-8FB5-0888C4C318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11F731-66F0-41A6-AA90-F9A2C0721A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Chart 9" descr=""/>
          <p:cNvPicPr/>
          <p:nvPr/>
        </p:nvPicPr>
        <p:blipFill>
          <a:blip r:embed="rId1"/>
          <a:stretch/>
        </p:blipFill>
        <p:spPr>
          <a:xfrm>
            <a:off x="774720" y="457200"/>
            <a:ext cx="3797280" cy="2859120"/>
          </a:xfrm>
          <a:prstGeom prst="rect">
            <a:avLst/>
          </a:prstGeom>
          <a:ln w="0">
            <a:noFill/>
          </a:ln>
        </p:spPr>
      </p:pic>
      <p:pic>
        <p:nvPicPr>
          <p:cNvPr id="49" name="Chart 10" descr=""/>
          <p:cNvPicPr/>
          <p:nvPr/>
        </p:nvPicPr>
        <p:blipFill>
          <a:blip r:embed="rId2"/>
          <a:stretch/>
        </p:blipFill>
        <p:spPr>
          <a:xfrm>
            <a:off x="4821120" y="378000"/>
            <a:ext cx="3799080" cy="2865240"/>
          </a:xfrm>
          <a:prstGeom prst="rect">
            <a:avLst/>
          </a:prstGeom>
          <a:ln w="0">
            <a:noFill/>
          </a:ln>
        </p:spPr>
      </p:pic>
      <p:pic>
        <p:nvPicPr>
          <p:cNvPr id="50" name="Chart 11" descr=""/>
          <p:cNvPicPr/>
          <p:nvPr/>
        </p:nvPicPr>
        <p:blipFill>
          <a:blip r:embed="rId3"/>
          <a:stretch/>
        </p:blipFill>
        <p:spPr>
          <a:xfrm>
            <a:off x="774720" y="3425760"/>
            <a:ext cx="3797280" cy="2865600"/>
          </a:xfrm>
          <a:prstGeom prst="rect">
            <a:avLst/>
          </a:prstGeom>
          <a:ln w="0">
            <a:noFill/>
          </a:ln>
        </p:spPr>
      </p:pic>
      <p:pic>
        <p:nvPicPr>
          <p:cNvPr id="51" name="Chart 12" descr=""/>
          <p:cNvPicPr/>
          <p:nvPr/>
        </p:nvPicPr>
        <p:blipFill>
          <a:blip r:embed="rId4"/>
          <a:stretch/>
        </p:blipFill>
        <p:spPr>
          <a:xfrm>
            <a:off x="4816440" y="3425760"/>
            <a:ext cx="3797280" cy="2865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Chart 11" descr=""/>
          <p:cNvPicPr/>
          <p:nvPr/>
        </p:nvPicPr>
        <p:blipFill>
          <a:blip r:embed="rId1"/>
          <a:stretch/>
        </p:blipFill>
        <p:spPr>
          <a:xfrm>
            <a:off x="914400" y="682560"/>
            <a:ext cx="3790800" cy="2865600"/>
          </a:xfrm>
          <a:prstGeom prst="rect">
            <a:avLst/>
          </a:prstGeom>
          <a:ln w="0">
            <a:noFill/>
          </a:ln>
        </p:spPr>
      </p:pic>
      <p:pic>
        <p:nvPicPr>
          <p:cNvPr id="53" name="Chart 12" descr=""/>
          <p:cNvPicPr/>
          <p:nvPr/>
        </p:nvPicPr>
        <p:blipFill>
          <a:blip r:embed="rId2"/>
          <a:stretch/>
        </p:blipFill>
        <p:spPr>
          <a:xfrm>
            <a:off x="4797360" y="682560"/>
            <a:ext cx="3797280" cy="2865600"/>
          </a:xfrm>
          <a:prstGeom prst="rect">
            <a:avLst/>
          </a:prstGeom>
          <a:ln w="0">
            <a:noFill/>
          </a:ln>
        </p:spPr>
      </p:pic>
      <p:sp>
        <p:nvSpPr>
          <p:cNvPr id="54" name="TextBox 15"/>
          <p:cNvSpPr/>
          <p:nvPr/>
        </p:nvSpPr>
        <p:spPr>
          <a:xfrm>
            <a:off x="394560" y="6519960"/>
            <a:ext cx="65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9999"/>
                </a:solidFill>
                <a:latin typeface="Arial"/>
              </a:rPr>
              <a:t>Supplementary Figure 4.  Comparison of CK signal intensity between fresh and frozen CAML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7T14:05:11Z</dcterms:created>
  <dc:creator>Peixuan Zhu</dc:creator>
  <dc:description/>
  <dc:language>en-US</dc:language>
  <cp:lastModifiedBy>Thai H Ho</cp:lastModifiedBy>
  <cp:lastPrinted>2015-11-04T21:50:17Z</cp:lastPrinted>
  <dcterms:modified xsi:type="dcterms:W3CDTF">2016-06-09T17:47:28Z</dcterms:modified>
  <cp:revision>116</cp:revision>
  <dc:subject/>
  <dc:title>Slide 1</dc:title>
</cp:coreProperties>
</file>